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879" autoAdjust="0"/>
    <p:restoredTop sz="94660"/>
  </p:normalViewPr>
  <p:slideViewPr>
    <p:cSldViewPr snapToGrid="0">
      <p:cViewPr>
        <p:scale>
          <a:sx n="100" d="100"/>
          <a:sy n="100" d="100"/>
        </p:scale>
        <p:origin x="-3174" y="-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447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028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839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758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2558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053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632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100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389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6779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871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A6B6BB-DD82-4BEC-B426-37ED8E56A839}" type="datetimeFigureOut">
              <a:rPr kumimoji="1" lang="ja-JP" altLang="en-US" smtClean="0"/>
              <a:t>2017/6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852EA-FD04-47E3-AC07-07DD7BCB5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859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 rot="16200000">
            <a:off x="833016" y="3131524"/>
            <a:ext cx="152798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4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bumin secretion</a:t>
            </a:r>
          </a:p>
          <a:p>
            <a:pPr algn="ctr">
              <a:defRPr sz="14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µg/ml/day)</a:t>
            </a:r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2593471" y="4791641"/>
            <a:ext cx="19949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Time after seeding </a:t>
            </a:r>
            <a:r>
              <a:rPr lang="en-US" altLang="ja-JP" sz="1200" b="1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)</a:t>
            </a:r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83333" y="5454280"/>
            <a:ext cx="56913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3: Fig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equential changes of albumin secretion from 3D spheroids isolated from CAG-ELuc/MI-MAC Tc mice. 3D culture was performed in the absence (open circles) or presence (filled circles) of 300 μM D-luciferin. Albumin concentration in the culture medium on the indicated culture day was measured by ELISA and divided by culture day. Error bars indicate standard deviations (n = 8)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4512" y="2216691"/>
            <a:ext cx="3228975" cy="2628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69677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20</TotalTime>
  <Words>86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jima</dc:creator>
  <cp:lastModifiedBy>nakajima</cp:lastModifiedBy>
  <cp:revision>228</cp:revision>
  <cp:lastPrinted>2016-08-27T04:43:09Z</cp:lastPrinted>
  <dcterms:created xsi:type="dcterms:W3CDTF">2014-01-04T11:44:56Z</dcterms:created>
  <dcterms:modified xsi:type="dcterms:W3CDTF">2017-06-14T11:53:54Z</dcterms:modified>
</cp:coreProperties>
</file>